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0FCBEC-8CE1-4461-BA46-EC45962DB2D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2C43FC-86BF-4DA3-986D-E6648D6FDF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35394E-889A-4A94-960A-5415AB6A009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4AB0F-8EB6-41BA-A898-B50A544F4E3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CB3C6F-B41D-4901-BDA1-9B6205AC22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E426FC-96FC-4ADD-AA28-1EE02E43CB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1C7CC8-A37E-481A-96BD-35554951AB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DA312B-2106-48D0-BE98-C9F9970CBF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A930E5-47E4-4FA2-9574-5B4539065F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1DBD71-41E7-47F0-8009-C46FB5CC89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F9E3D9-C1D1-4634-849D-C89CEEE30D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C1CE3A-9CCA-4FF2-ADAE-4DE1FE5D70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CH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7FF6D1-3BAF-4289-AC61-2A0F0FDDB298}" type="slidenum">
              <a:rPr b="0" lang="de-CH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71280" y="469800"/>
          <a:ext cx="4643640" cy="2887920"/>
        </p:xfrm>
        <a:graphic>
          <a:graphicData uri="http://schemas.openxmlformats.org/drawingml/2006/table">
            <a:tbl>
              <a:tblPr/>
              <a:tblGrid>
                <a:gridCol w="928800"/>
                <a:gridCol w="399960"/>
                <a:gridCol w="398520"/>
                <a:gridCol w="399960"/>
                <a:gridCol w="439920"/>
                <a:gridCol w="439560"/>
                <a:gridCol w="398520"/>
                <a:gridCol w="400320"/>
                <a:gridCol w="399960"/>
                <a:gridCol w="438120"/>
              </a:tblGrid>
              <a:tr h="15732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5876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llele frequenc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enotype frequenc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3 bp inde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/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/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/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ge &gt;8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6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346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62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14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ge 5-6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5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112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ot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4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14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96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76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llele frequenc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enotype frequenc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2 bp inde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/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/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/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414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ge &gt;8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5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07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128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112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ge 5-6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4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14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ot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112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14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3 &amp; 12 bp inde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aplotype frequenc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112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-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-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-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14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ge &gt;8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5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27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112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ge 5-6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14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ot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1"/>
          <p:cNvSpPr/>
          <p:nvPr/>
        </p:nvSpPr>
        <p:spPr>
          <a:xfrm>
            <a:off x="71280" y="63360"/>
            <a:ext cx="46436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1371600"/>
                <a:tab algn="l" pos="2286000"/>
                <a:tab algn="l" pos="3200400"/>
                <a:tab algn="l" pos="4114800"/>
                <a:tab algn="l" pos="5029200"/>
                <a:tab algn="l" pos="5943600"/>
                <a:tab algn="l" pos="68580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Times New Roman"/>
              </a:rPr>
              <a:t>Table S1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Times New Roman"/>
              </a:rPr>
              <a:t>Allele, genotype and haplotype frequencies of the 23 bp indel and the 12 bp indel polymorphisms in geriatric compared to average aged BSE cattle.*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1371600"/>
                <a:tab algn="l" pos="2286000"/>
                <a:tab algn="l" pos="3200400"/>
                <a:tab algn="l" pos="4114800"/>
                <a:tab algn="l" pos="5029200"/>
                <a:tab algn="l" pos="5943600"/>
                <a:tab algn="l" pos="68580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Rectangle 1"/>
          <p:cNvSpPr/>
          <p:nvPr/>
        </p:nvSpPr>
        <p:spPr>
          <a:xfrm>
            <a:off x="0" y="3528000"/>
            <a:ext cx="46432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1371600"/>
                <a:tab algn="l" pos="2286000"/>
                <a:tab algn="l" pos="3200400"/>
                <a:tab algn="l" pos="4114800"/>
                <a:tab algn="l" pos="5029200"/>
                <a:tab algn="l" pos="5943600"/>
                <a:tab algn="l" pos="68580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Times New Roman"/>
              </a:rPr>
              <a:t>* D: deletion, I: insertion, P: p-value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1371600"/>
                <a:tab algn="l" pos="2286000"/>
                <a:tab algn="l" pos="3200400"/>
                <a:tab algn="l" pos="4114800"/>
                <a:tab algn="l" pos="5029200"/>
                <a:tab algn="l" pos="5943600"/>
                <a:tab algn="l" pos="68580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5-12T09:48:43Z</dcterms:created>
  <dc:creator>anonymus</dc:creator>
  <dc:description/>
  <dc:language>en-US</dc:language>
  <cp:lastModifiedBy>anonymus</cp:lastModifiedBy>
  <dcterms:modified xsi:type="dcterms:W3CDTF">2009-05-12T09:49:43Z</dcterms:modified>
  <cp:revision>1</cp:revision>
  <dc:subject/>
  <dc:title>Slide 1</dc:title>
</cp:coreProperties>
</file>